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7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E"/>
    <a:srgbClr val="FE0000"/>
    <a:srgbClr val="00BF00"/>
    <a:srgbClr val="AC06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613" autoAdjust="0"/>
    <p:restoredTop sz="95380" autoAdjust="0"/>
  </p:normalViewPr>
  <p:slideViewPr>
    <p:cSldViewPr>
      <p:cViewPr varScale="1">
        <p:scale>
          <a:sx n="104" d="100"/>
          <a:sy n="104" d="100"/>
        </p:scale>
        <p:origin x="2910" y="11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C67A7EB-D8FA-402C-93F1-129C8FDAD13F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57A75BAE-0FEB-469F-A007-1CB9D3A6AA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036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5800" y="77450"/>
            <a:ext cx="6172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PArray-isolated single cells from DNA BCT® tubes 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6169207"/>
              </p:ext>
            </p:extLst>
          </p:nvPr>
        </p:nvGraphicFramePr>
        <p:xfrm>
          <a:off x="1194976" y="457200"/>
          <a:ext cx="5254315" cy="28344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0863"/>
                <a:gridCol w="1050863"/>
                <a:gridCol w="1050863"/>
                <a:gridCol w="1050863"/>
                <a:gridCol w="1050863"/>
              </a:tblGrid>
              <a:tr h="283443">
                <a:tc>
                  <a:txBody>
                    <a:bodyPr/>
                    <a:lstStyle/>
                    <a:p>
                      <a:pPr algn="ctr"/>
                      <a:r>
                        <a:rPr lang="en-US" sz="1100" b="0" u="none" dirty="0" smtClean="0"/>
                        <a:t>DAPI</a:t>
                      </a:r>
                      <a:endParaRPr lang="en-US" sz="1100" b="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u="none" dirty="0" err="1" smtClean="0"/>
                        <a:t>Brightfield</a:t>
                      </a:r>
                      <a:endParaRPr lang="en-US" sz="1100" b="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u="none" dirty="0" smtClean="0"/>
                        <a:t>HER2-PE</a:t>
                      </a:r>
                      <a:endParaRPr lang="en-US" sz="1100" b="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u="none" dirty="0" smtClean="0"/>
                        <a:t>CD45</a:t>
                      </a:r>
                      <a:r>
                        <a:rPr lang="en-US" sz="1100" b="0" u="none" baseline="0" dirty="0" smtClean="0"/>
                        <a:t>-AF488</a:t>
                      </a:r>
                      <a:endParaRPr lang="en-US" sz="1100" b="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u="none" dirty="0" smtClean="0">
                          <a:latin typeface="+mn-lt"/>
                          <a:cs typeface="+mn-cs"/>
                        </a:rPr>
                        <a:t>EpCAM-AF647</a:t>
                      </a:r>
                      <a:endParaRPr lang="en-US" sz="1100" b="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222686" y="740643"/>
            <a:ext cx="5254314" cy="101195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222686" y="1752600"/>
            <a:ext cx="5254314" cy="100725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222685" y="2759850"/>
            <a:ext cx="5254315" cy="100254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222685" y="3755026"/>
            <a:ext cx="5254315" cy="100725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489889" y="1143000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+mj-lt"/>
                <a:cs typeface="Times New Roman" panose="02020603050405020304" pitchFamily="18" charset="0"/>
              </a:rPr>
              <a:t>HCC1954</a:t>
            </a:r>
            <a:endParaRPr lang="en-US" sz="11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85455" y="2162383"/>
            <a:ext cx="5164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+mj-lt"/>
                <a:cs typeface="Times New Roman" panose="02020603050405020304" pitchFamily="18" charset="0"/>
              </a:rPr>
              <a:t>MCF7</a:t>
            </a:r>
            <a:endParaRPr lang="en-US" sz="11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28600" y="3130096"/>
            <a:ext cx="9733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+mj-lt"/>
                <a:cs typeface="Times New Roman" panose="02020603050405020304" pitchFamily="18" charset="0"/>
              </a:rPr>
              <a:t>MDA-MB-453</a:t>
            </a:r>
            <a:endParaRPr lang="en-US" sz="11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39957" y="4148883"/>
            <a:ext cx="4619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+mj-lt"/>
                <a:cs typeface="Times New Roman" panose="02020603050405020304" pitchFamily="18" charset="0"/>
              </a:rPr>
              <a:t>WBC</a:t>
            </a:r>
            <a:endParaRPr lang="en-US" sz="1100" dirty="0">
              <a:latin typeface="+mj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9267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909</TotalTime>
  <Words>21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outline</dc:title>
  <dc:creator>Erica</dc:creator>
  <cp:lastModifiedBy>Stephanie Yee</cp:lastModifiedBy>
  <cp:revision>1176</cp:revision>
  <cp:lastPrinted>2016-01-25T19:44:34Z</cp:lastPrinted>
  <dcterms:created xsi:type="dcterms:W3CDTF">2015-02-12T22:03:54Z</dcterms:created>
  <dcterms:modified xsi:type="dcterms:W3CDTF">2016-01-26T16:50:15Z</dcterms:modified>
</cp:coreProperties>
</file>